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  <p:sldId id="260" r:id="rId4"/>
    <p:sldId id="261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5" autoAdjust="0"/>
    <p:restoredTop sz="94660"/>
  </p:normalViewPr>
  <p:slideViewPr>
    <p:cSldViewPr snapToGrid="0">
      <p:cViewPr varScale="1">
        <p:scale>
          <a:sx n="89" d="100"/>
          <a:sy n="89" d="100"/>
        </p:scale>
        <p:origin x="12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9F7268-3428-4B55-AD75-EDABAD93EEA5}" type="datetimeFigureOut">
              <a:rPr lang="en-US" smtClean="0"/>
              <a:t>3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1C0-9897-4A49-9A44-C08E2358C1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20095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9F7268-3428-4B55-AD75-EDABAD93EEA5}" type="datetimeFigureOut">
              <a:rPr lang="en-US" smtClean="0"/>
              <a:t>3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1C0-9897-4A49-9A44-C08E2358C1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52323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9F7268-3428-4B55-AD75-EDABAD93EEA5}" type="datetimeFigureOut">
              <a:rPr lang="en-US" smtClean="0"/>
              <a:t>3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1C0-9897-4A49-9A44-C08E2358C1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28641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9F7268-3428-4B55-AD75-EDABAD93EEA5}" type="datetimeFigureOut">
              <a:rPr lang="en-US" smtClean="0"/>
              <a:t>3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1C0-9897-4A49-9A44-C08E2358C1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15174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9F7268-3428-4B55-AD75-EDABAD93EEA5}" type="datetimeFigureOut">
              <a:rPr lang="en-US" smtClean="0"/>
              <a:t>3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1C0-9897-4A49-9A44-C08E2358C1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31502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9F7268-3428-4B55-AD75-EDABAD93EEA5}" type="datetimeFigureOut">
              <a:rPr lang="en-US" smtClean="0"/>
              <a:t>3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1C0-9897-4A49-9A44-C08E2358C1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23141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9F7268-3428-4B55-AD75-EDABAD93EEA5}" type="datetimeFigureOut">
              <a:rPr lang="en-US" smtClean="0"/>
              <a:t>3/1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1C0-9897-4A49-9A44-C08E2358C1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19523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9F7268-3428-4B55-AD75-EDABAD93EEA5}" type="datetimeFigureOut">
              <a:rPr lang="en-US" smtClean="0"/>
              <a:t>3/1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1C0-9897-4A49-9A44-C08E2358C1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58985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9F7268-3428-4B55-AD75-EDABAD93EEA5}" type="datetimeFigureOut">
              <a:rPr lang="en-US" smtClean="0"/>
              <a:t>3/1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1C0-9897-4A49-9A44-C08E2358C1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6953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9F7268-3428-4B55-AD75-EDABAD93EEA5}" type="datetimeFigureOut">
              <a:rPr lang="en-US" smtClean="0"/>
              <a:t>3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1C0-9897-4A49-9A44-C08E2358C1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49684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9F7268-3428-4B55-AD75-EDABAD93EEA5}" type="datetimeFigureOut">
              <a:rPr lang="en-US" smtClean="0"/>
              <a:t>3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1C0-9897-4A49-9A44-C08E2358C1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32128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9F7268-3428-4B55-AD75-EDABAD93EEA5}" type="datetimeFigureOut">
              <a:rPr lang="en-US" smtClean="0"/>
              <a:t>3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4E81C0-9897-4A49-9A44-C08E2358C1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56505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jpe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08791" y="290456"/>
            <a:ext cx="56585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Uncropped blots for Figure 2</a:t>
            </a:r>
          </a:p>
        </p:txBody>
      </p:sp>
      <p:pic>
        <p:nvPicPr>
          <p:cNvPr id="3" name="Picture 2" descr="C:\Users\Gabizonr\Desktop\peer pub original\final response to plos\TG paper\corrected fig 2E.jpg"/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789" t="34828" r="29005" b="44445"/>
          <a:stretch/>
        </p:blipFill>
        <p:spPr bwMode="auto">
          <a:xfrm>
            <a:off x="4514850" y="2967037"/>
            <a:ext cx="3162300" cy="923925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28513686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08791" y="290456"/>
            <a:ext cx="70462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Uncropped blots for Figure 5</a:t>
            </a:r>
          </a:p>
        </p:txBody>
      </p:sp>
      <p:grpSp>
        <p:nvGrpSpPr>
          <p:cNvPr id="5" name="Group 4"/>
          <p:cNvGrpSpPr/>
          <p:nvPr/>
        </p:nvGrpSpPr>
        <p:grpSpPr>
          <a:xfrm>
            <a:off x="249331" y="1017059"/>
            <a:ext cx="4781550" cy="1850526"/>
            <a:chOff x="249331" y="1017059"/>
            <a:chExt cx="4781550" cy="1850526"/>
          </a:xfrm>
        </p:grpSpPr>
        <p:pic>
          <p:nvPicPr>
            <p:cNvPr id="3" name="Picture 2" descr="C:\Users\Gabizonr\Desktop\peer pub original\final response to plos\TG paper\suplement 5a.jpg"/>
            <p:cNvPicPr/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417" t="30983" r="9134" b="35684"/>
            <a:stretch/>
          </p:blipFill>
          <p:spPr bwMode="auto">
            <a:xfrm>
              <a:off x="249331" y="1381685"/>
              <a:ext cx="4781550" cy="148590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2" name="TextBox 1"/>
            <p:cNvSpPr txBox="1"/>
            <p:nvPr/>
          </p:nvSpPr>
          <p:spPr>
            <a:xfrm>
              <a:off x="408791" y="1017059"/>
              <a:ext cx="7395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5A</a:t>
              </a:r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634701" y="3589482"/>
            <a:ext cx="2543175" cy="1320968"/>
            <a:chOff x="408791" y="3953435"/>
            <a:chExt cx="2543175" cy="1320968"/>
          </a:xfrm>
        </p:grpSpPr>
        <p:pic>
          <p:nvPicPr>
            <p:cNvPr id="6" name="Picture 5" descr="C:\Users\Gabizonr\Desktop\peer pub original\final response to plos\TG paper\suplement 5b.jpg"/>
            <p:cNvPicPr/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063" t="40812" r="16988" b="23504"/>
            <a:stretch/>
          </p:blipFill>
          <p:spPr bwMode="auto">
            <a:xfrm>
              <a:off x="408791" y="4273008"/>
              <a:ext cx="2543175" cy="1001395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7" name="TextBox 6"/>
            <p:cNvSpPr txBox="1"/>
            <p:nvPr/>
          </p:nvSpPr>
          <p:spPr>
            <a:xfrm>
              <a:off x="408791" y="3953435"/>
              <a:ext cx="49216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5B</a:t>
              </a:r>
            </a:p>
          </p:txBody>
        </p:sp>
      </p:grpSp>
      <p:grpSp>
        <p:nvGrpSpPr>
          <p:cNvPr id="12" name="Group 11"/>
          <p:cNvGrpSpPr/>
          <p:nvPr/>
        </p:nvGrpSpPr>
        <p:grpSpPr>
          <a:xfrm>
            <a:off x="6548717" y="1904331"/>
            <a:ext cx="5328592" cy="3888432"/>
            <a:chOff x="8245288" y="2353235"/>
            <a:chExt cx="3581400" cy="2800985"/>
          </a:xfrm>
        </p:grpSpPr>
        <p:pic>
          <p:nvPicPr>
            <p:cNvPr id="13" name="Picture 12" descr="C:\Users\Gabizonr\Desktop\peer pub original\final response to plos\TG paper\suplement 5c.jpg"/>
            <p:cNvPicPr/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211" t="20086" r="13462" b="8974"/>
            <a:stretch/>
          </p:blipFill>
          <p:spPr bwMode="auto">
            <a:xfrm>
              <a:off x="8245288" y="2752650"/>
              <a:ext cx="3581400" cy="240157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14" name="TextBox 13"/>
            <p:cNvSpPr txBox="1"/>
            <p:nvPr/>
          </p:nvSpPr>
          <p:spPr>
            <a:xfrm>
              <a:off x="8323729" y="2353235"/>
              <a:ext cx="56477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5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9797504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08791" y="290456"/>
            <a:ext cx="50453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Uncropped blots for Figure 6</a:t>
            </a:r>
          </a:p>
        </p:txBody>
      </p:sp>
      <p:pic>
        <p:nvPicPr>
          <p:cNvPr id="3" name="Picture 2" descr="C:\Users\Gabizonr\Desktop\peer pub original\final response to plos\TG paper\suplement 65.jpg"/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80" t="29254" r="5671"/>
          <a:stretch/>
        </p:blipFill>
        <p:spPr bwMode="auto">
          <a:xfrm>
            <a:off x="990105" y="1191702"/>
            <a:ext cx="9365316" cy="4956736"/>
          </a:xfrm>
          <a:prstGeom prst="rect">
            <a:avLst/>
          </a:prstGeom>
          <a:noFill/>
          <a:extLst/>
        </p:spPr>
      </p:pic>
    </p:spTree>
    <p:extLst>
      <p:ext uri="{BB962C8B-B14F-4D97-AF65-F5344CB8AC3E}">
        <p14:creationId xmlns:p14="http://schemas.microsoft.com/office/powerpoint/2010/main" val="39525340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08791" y="290456"/>
            <a:ext cx="50453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Uncropped blots for Figure 7</a:t>
            </a:r>
          </a:p>
        </p:txBody>
      </p:sp>
      <p:pic>
        <p:nvPicPr>
          <p:cNvPr id="3" name="Picture 2" descr="C:\Users\Gabizonr\Desktop\peer pub original\final response to plos\TG paper\fig 7.jpg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8316" y="1296801"/>
            <a:ext cx="6375027" cy="4055129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7993468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79</TotalTime>
  <Words>23</Words>
  <Application>Microsoft Office PowerPoint</Application>
  <PresentationFormat>Widescreen</PresentationFormat>
  <Paragraphs>7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ly Berrin</dc:creator>
  <cp:lastModifiedBy>Lily Berrin</cp:lastModifiedBy>
  <cp:revision>8</cp:revision>
  <dcterms:created xsi:type="dcterms:W3CDTF">2016-12-15T00:13:45Z</dcterms:created>
  <dcterms:modified xsi:type="dcterms:W3CDTF">2017-03-15T16:12:22Z</dcterms:modified>
</cp:coreProperties>
</file>